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jpeg" ContentType="image/jpeg"/>
  <Override PartName="/ppt/media/image3.jpeg" ContentType="image/jpeg"/>
  <Override PartName="/ppt/media/image4.png" ContentType="image/png"/>
  <Override PartName="/ppt/media/image5.png" ContentType="image/png"/>
  <Override PartName="/ppt/media/image6.png" ContentType="image/png"/>
  <Override PartName="/ppt/media/image7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4B528D-BC77-45EC-9FC5-2D34A4BAB8B7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7184A6-B827-45FB-BADC-0C22E14B80D5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5EFB9B-F1EC-4184-9556-97EBA8C18D14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E00374-BF4D-4FF0-AEE5-4AF8C20AFBF0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0217D-C5EE-4947-809D-C86157E78F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E7054-D01A-45F1-BBBE-B33E9BB8E3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6D51D-C8FA-46A8-8240-AF41520E55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F9712-70A6-4EB8-B3E3-C56A810CFC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8DF15-EAA6-46CC-BE0D-FCAB1BE7DC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EAB92-21FF-4CD7-978F-B5CCA9AF07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8C09D-89BA-4829-8589-E7D6E8FDA2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01C77-7603-461B-9F74-9CC4098FCB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9A612-3E05-4789-8378-ED950EA2F9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892AA-93A2-4382-BD23-ACD6D10218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E6CFA-02D6-48E4-966A-2D720EEA0F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05C8D-A94A-4B33-8F3F-CE69F93DD1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FCDD0E-12EE-47FE-B2B6-5EF2ECD91DB7}" type="datetime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8/29/26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22984F-B89E-405C-89B3-C1257DE832F3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5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6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6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6A1D24-AEF6-4CE2-8FA7-85732B9C670A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Slide Number Placeholder 3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BA340A-250C-4566-9234-4CEC49C0B7EF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50" name="Object 4"/>
          <p:cNvGraphicFramePr/>
          <p:nvPr/>
        </p:nvGraphicFramePr>
        <p:xfrm>
          <a:off x="2421000" y="3087720"/>
          <a:ext cx="2952720" cy="21733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1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21000" y="3087720"/>
                    <a:ext cx="2952720" cy="2173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Text Box 5"/>
          <p:cNvSpPr/>
          <p:nvPr/>
        </p:nvSpPr>
        <p:spPr>
          <a:xfrm>
            <a:off x="2190960" y="3159000"/>
            <a:ext cx="45036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9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Text Box 6"/>
          <p:cNvSpPr/>
          <p:nvPr/>
        </p:nvSpPr>
        <p:spPr>
          <a:xfrm rot="16200000">
            <a:off x="1272600" y="3934440"/>
            <a:ext cx="1639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ercentage of Cell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with Neurite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Text Box 7"/>
          <p:cNvSpPr/>
          <p:nvPr/>
        </p:nvSpPr>
        <p:spPr>
          <a:xfrm>
            <a:off x="2841840" y="5075280"/>
            <a:ext cx="206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ontrol                 AG49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5" name="Group 16"/>
          <p:cNvGrpSpPr/>
          <p:nvPr/>
        </p:nvGrpSpPr>
        <p:grpSpPr>
          <a:xfrm>
            <a:off x="981000" y="684360"/>
            <a:ext cx="5193000" cy="2090520"/>
            <a:chOff x="981000" y="684360"/>
            <a:chExt cx="5193000" cy="2090520"/>
          </a:xfrm>
        </p:grpSpPr>
        <p:pic>
          <p:nvPicPr>
            <p:cNvPr id="56" name="Picture 8" descr="CONTROl PC12"/>
            <p:cNvPicPr/>
            <p:nvPr/>
          </p:nvPicPr>
          <p:blipFill>
            <a:blip r:embed="rId3">
              <a:lum bright="-6000"/>
            </a:blip>
            <a:stretch/>
          </p:blipFill>
          <p:spPr>
            <a:xfrm>
              <a:off x="981000" y="684360"/>
              <a:ext cx="2519280" cy="209052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pic>
          <p:nvPicPr>
            <p:cNvPr id="57" name="Picture 9" descr="AG490 PC12"/>
            <p:cNvPicPr/>
            <p:nvPr/>
          </p:nvPicPr>
          <p:blipFill>
            <a:blip r:embed="rId4">
              <a:lum bright="6000"/>
            </a:blip>
            <a:stretch/>
          </p:blipFill>
          <p:spPr>
            <a:xfrm>
              <a:off x="3645000" y="684360"/>
              <a:ext cx="2519280" cy="2087280"/>
            </a:xfrm>
            <a:prstGeom prst="rect">
              <a:avLst/>
            </a:prstGeom>
            <a:ln w="25560">
              <a:solidFill>
                <a:srgbClr val="000000"/>
              </a:solidFill>
              <a:miter/>
            </a:ln>
          </p:spPr>
        </p:pic>
        <p:sp>
          <p:nvSpPr>
            <p:cNvPr id="58" name="Text Box 10"/>
            <p:cNvSpPr/>
            <p:nvPr/>
          </p:nvSpPr>
          <p:spPr>
            <a:xfrm>
              <a:off x="1914480" y="2466720"/>
              <a:ext cx="1610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Control PC12 cell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 Box 11"/>
            <p:cNvSpPr/>
            <p:nvPr/>
          </p:nvSpPr>
          <p:spPr>
            <a:xfrm>
              <a:off x="4623120" y="2452320"/>
              <a:ext cx="1550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G490 PC12 cell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0" name="Text Box 14"/>
          <p:cNvSpPr/>
          <p:nvPr/>
        </p:nvSpPr>
        <p:spPr>
          <a:xfrm>
            <a:off x="314640" y="7556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15"/>
          <p:cNvSpPr/>
          <p:nvPr/>
        </p:nvSpPr>
        <p:spPr>
          <a:xfrm>
            <a:off x="319320" y="299556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Rectangle 17"/>
          <p:cNvSpPr/>
          <p:nvPr/>
        </p:nvSpPr>
        <p:spPr>
          <a:xfrm>
            <a:off x="189000" y="5893560"/>
            <a:ext cx="656568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</a:rPr>
              <a:t>Effect of AG490 on neuritic outgrowth of PC12 cells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C12 cells were allowed to differentiate in the presence of 50 μM AG490 (Jak2/Stat3 inhibitor) for 4 days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he cells were seen under light microscop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. (B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Number of cells with neurites per field was counted. An average of 13 fields was taken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he untreated control was taken as 100%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(C and D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Neurite length was measured in randomly chosen cells. Statistical significance of the difference was determined using ANOVA. The result shows the mean ± SE of n=3 combined experiments (**p&lt;0.01, *p&lt;0.05). Neurite lengths were measured by tracing individual neurites (as described in experimental procedures) and results are expressed a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C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average of total primary and secondary neurite lengths or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D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average number of neurites per cell. Scale bar, 5µM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(E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PC12 cells were allowed to grow in the presence of increasing the concentration of AG490 (0 μM - 100 μM) and MTT assay was performed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4366080" y="450072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Box 16"/>
          <p:cNvSpPr/>
          <p:nvPr/>
        </p:nvSpPr>
        <p:spPr>
          <a:xfrm>
            <a:off x="2197800" y="8388360"/>
            <a:ext cx="215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600" spc="-1" strike="noStrike">
                <a:solidFill>
                  <a:srgbClr val="000000"/>
                </a:solidFill>
                <a:latin typeface="Times New Roman"/>
              </a:rPr>
              <a:t>Supplementary File S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6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27504F-73E5-4A0B-AB6D-E52A3E9D2C13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Slide Number Placeholder 3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50AC1E-5E71-49AA-8B79-5ECF4259DCE6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6"/>
          <p:cNvSpPr/>
          <p:nvPr/>
        </p:nvSpPr>
        <p:spPr>
          <a:xfrm>
            <a:off x="1411920" y="14000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7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7"/>
          <p:cNvSpPr/>
          <p:nvPr/>
        </p:nvSpPr>
        <p:spPr>
          <a:xfrm>
            <a:off x="1501200" y="28987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8"/>
          <p:cNvSpPr/>
          <p:nvPr/>
        </p:nvSpPr>
        <p:spPr>
          <a:xfrm>
            <a:off x="1423080" y="1114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9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9"/>
          <p:cNvSpPr/>
          <p:nvPr/>
        </p:nvSpPr>
        <p:spPr>
          <a:xfrm>
            <a:off x="1432440" y="16956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10"/>
          <p:cNvSpPr/>
          <p:nvPr/>
        </p:nvSpPr>
        <p:spPr>
          <a:xfrm>
            <a:off x="1423080" y="20019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4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Text Box 11"/>
          <p:cNvSpPr/>
          <p:nvPr/>
        </p:nvSpPr>
        <p:spPr>
          <a:xfrm>
            <a:off x="1413360" y="26240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12"/>
          <p:cNvSpPr/>
          <p:nvPr/>
        </p:nvSpPr>
        <p:spPr>
          <a:xfrm>
            <a:off x="1432440" y="23130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13"/>
          <p:cNvSpPr/>
          <p:nvPr/>
        </p:nvSpPr>
        <p:spPr>
          <a:xfrm rot="16200000">
            <a:off x="511200" y="1748160"/>
            <a:ext cx="1479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verage Neurite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Length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µ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14"/>
          <p:cNvSpPr/>
          <p:nvPr/>
        </p:nvSpPr>
        <p:spPr>
          <a:xfrm>
            <a:off x="2215440" y="3056040"/>
            <a:ext cx="2734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rimary                        Secondary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eurite                            Neurit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15"/>
          <p:cNvSpPr/>
          <p:nvPr/>
        </p:nvSpPr>
        <p:spPr>
          <a:xfrm>
            <a:off x="2759760" y="3519360"/>
            <a:ext cx="175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Degree of Branchin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17"/>
          <p:cNvSpPr/>
          <p:nvPr/>
        </p:nvSpPr>
        <p:spPr>
          <a:xfrm>
            <a:off x="1659240" y="400068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 Box 18"/>
          <p:cNvSpPr/>
          <p:nvPr/>
        </p:nvSpPr>
        <p:spPr>
          <a:xfrm>
            <a:off x="1654200" y="423216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 Box 19"/>
          <p:cNvSpPr/>
          <p:nvPr/>
        </p:nvSpPr>
        <p:spPr>
          <a:xfrm>
            <a:off x="1654200" y="447372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 Box 20"/>
          <p:cNvSpPr/>
          <p:nvPr/>
        </p:nvSpPr>
        <p:spPr>
          <a:xfrm>
            <a:off x="1652760" y="474516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21"/>
          <p:cNvSpPr/>
          <p:nvPr/>
        </p:nvSpPr>
        <p:spPr>
          <a:xfrm>
            <a:off x="1654200" y="551808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22"/>
          <p:cNvSpPr/>
          <p:nvPr/>
        </p:nvSpPr>
        <p:spPr>
          <a:xfrm>
            <a:off x="1662120" y="524340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Text Box 23"/>
          <p:cNvSpPr/>
          <p:nvPr/>
        </p:nvSpPr>
        <p:spPr>
          <a:xfrm>
            <a:off x="1652760" y="576108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Text Box 24"/>
          <p:cNvSpPr/>
          <p:nvPr/>
        </p:nvSpPr>
        <p:spPr>
          <a:xfrm>
            <a:off x="1652760" y="500364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 Box 25"/>
          <p:cNvSpPr/>
          <p:nvPr/>
        </p:nvSpPr>
        <p:spPr>
          <a:xfrm>
            <a:off x="1654200" y="601812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Text Box 26"/>
          <p:cNvSpPr/>
          <p:nvPr/>
        </p:nvSpPr>
        <p:spPr>
          <a:xfrm rot="16200000">
            <a:off x="577440" y="4790880"/>
            <a:ext cx="1730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verage Number of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eurites Per Cel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Text Box 27"/>
          <p:cNvSpPr/>
          <p:nvPr/>
        </p:nvSpPr>
        <p:spPr>
          <a:xfrm>
            <a:off x="1891080" y="6170760"/>
            <a:ext cx="3091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ontrol       IGF-1      AG490    AG49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                                            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 IGF-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Text Box 28"/>
          <p:cNvSpPr/>
          <p:nvPr/>
        </p:nvSpPr>
        <p:spPr>
          <a:xfrm>
            <a:off x="314640" y="16113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Text Box 29"/>
          <p:cNvSpPr/>
          <p:nvPr/>
        </p:nvSpPr>
        <p:spPr>
          <a:xfrm>
            <a:off x="319320" y="44276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Text Box 34"/>
          <p:cNvSpPr/>
          <p:nvPr/>
        </p:nvSpPr>
        <p:spPr>
          <a:xfrm>
            <a:off x="3836520" y="23954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AutoShape 36"/>
          <p:cNvSpPr/>
          <p:nvPr/>
        </p:nvSpPr>
        <p:spPr>
          <a:xfrm rot="5400000">
            <a:off x="2255400" y="1055520"/>
            <a:ext cx="96840" cy="623880"/>
          </a:xfrm>
          <a:custGeom>
            <a:avLst/>
            <a:gdLst>
              <a:gd name="textAreaLeft" fmla="*/ 28440 w 96840"/>
              <a:gd name="textAreaRight" fmla="*/ 97200 w 96840"/>
              <a:gd name="textAreaTop" fmla="*/ 0 h 623880"/>
              <a:gd name="textAreaBottom" fmla="*/ 624240 h 623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92" name="Object 38"/>
          <p:cNvGraphicFramePr/>
          <p:nvPr/>
        </p:nvGraphicFramePr>
        <p:xfrm>
          <a:off x="1628640" y="1042920"/>
          <a:ext cx="3600720" cy="21607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93" name="Object 3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28640" y="1042920"/>
                    <a:ext cx="3600720" cy="216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4" name="Object 31"/>
          <p:cNvGraphicFramePr/>
          <p:nvPr/>
        </p:nvGraphicFramePr>
        <p:xfrm>
          <a:off x="4851360" y="1166760"/>
          <a:ext cx="1152720" cy="10080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95" name="Object 3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851360" y="1166760"/>
                    <a:ext cx="1152720" cy="1008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6" name="AutoShape 40"/>
          <p:cNvSpPr/>
          <p:nvPr/>
        </p:nvSpPr>
        <p:spPr>
          <a:xfrm rot="5400000">
            <a:off x="2565360" y="394920"/>
            <a:ext cx="71280" cy="1224000"/>
          </a:xfrm>
          <a:custGeom>
            <a:avLst/>
            <a:gdLst>
              <a:gd name="textAreaLeft" fmla="*/ 20880 w 71280"/>
              <a:gd name="textAreaRight" fmla="*/ 71640 w 71280"/>
              <a:gd name="textAreaTop" fmla="*/ 0 h 1224000"/>
              <a:gd name="textAreaBottom" fmla="*/ 122436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AutoShape 41"/>
          <p:cNvSpPr/>
          <p:nvPr/>
        </p:nvSpPr>
        <p:spPr>
          <a:xfrm rot="5400000">
            <a:off x="3920760" y="2325600"/>
            <a:ext cx="96840" cy="623880"/>
          </a:xfrm>
          <a:custGeom>
            <a:avLst/>
            <a:gdLst>
              <a:gd name="textAreaLeft" fmla="*/ 28440 w 96840"/>
              <a:gd name="textAreaRight" fmla="*/ 97200 w 96840"/>
              <a:gd name="textAreaTop" fmla="*/ 0 h 623880"/>
              <a:gd name="textAreaBottom" fmla="*/ 624240 h 623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98" name="Object 42"/>
          <p:cNvGraphicFramePr/>
          <p:nvPr/>
        </p:nvGraphicFramePr>
        <p:xfrm>
          <a:off x="1773360" y="3956040"/>
          <a:ext cx="3384360" cy="227160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99" name="Object 4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773360" y="3956040"/>
                    <a:ext cx="3384360" cy="22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0" name="Object 43"/>
          <p:cNvGraphicFramePr/>
          <p:nvPr/>
        </p:nvGraphicFramePr>
        <p:xfrm>
          <a:off x="4869000" y="4068720"/>
          <a:ext cx="1152360" cy="10080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101" name="Object 4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869000" y="4068720"/>
                    <a:ext cx="1152360" cy="1008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2" name="Text Box 32"/>
          <p:cNvSpPr/>
          <p:nvPr/>
        </p:nvSpPr>
        <p:spPr>
          <a:xfrm>
            <a:off x="2134080" y="11160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AutoShape 45"/>
          <p:cNvSpPr/>
          <p:nvPr/>
        </p:nvSpPr>
        <p:spPr>
          <a:xfrm rot="5400000">
            <a:off x="4077000" y="1971000"/>
            <a:ext cx="71640" cy="936360"/>
          </a:xfrm>
          <a:custGeom>
            <a:avLst/>
            <a:gdLst>
              <a:gd name="textAreaLeft" fmla="*/ 20880 w 71640"/>
              <a:gd name="textAreaRight" fmla="*/ 72000 w 71640"/>
              <a:gd name="textAreaTop" fmla="*/ 0 h 936360"/>
              <a:gd name="textAreaBottom" fmla="*/ 936720 h 936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AutoShape 46"/>
          <p:cNvSpPr/>
          <p:nvPr/>
        </p:nvSpPr>
        <p:spPr>
          <a:xfrm rot="5400000">
            <a:off x="2421720" y="708480"/>
            <a:ext cx="71280" cy="936720"/>
          </a:xfrm>
          <a:custGeom>
            <a:avLst/>
            <a:gdLst>
              <a:gd name="textAreaLeft" fmla="*/ 20880 w 71280"/>
              <a:gd name="textAreaRight" fmla="*/ 71640 w 71280"/>
              <a:gd name="textAreaTop" fmla="*/ 0 h 936720"/>
              <a:gd name="textAreaBottom" fmla="*/ 937080 h 936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Text Box 32"/>
          <p:cNvSpPr/>
          <p:nvPr/>
        </p:nvSpPr>
        <p:spPr>
          <a:xfrm>
            <a:off x="4077360" y="19796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32"/>
          <p:cNvSpPr/>
          <p:nvPr/>
        </p:nvSpPr>
        <p:spPr>
          <a:xfrm>
            <a:off x="3934440" y="21956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32"/>
          <p:cNvSpPr/>
          <p:nvPr/>
        </p:nvSpPr>
        <p:spPr>
          <a:xfrm>
            <a:off x="2277000" y="9158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AutoShape 50"/>
          <p:cNvSpPr/>
          <p:nvPr/>
        </p:nvSpPr>
        <p:spPr>
          <a:xfrm rot="5400000">
            <a:off x="4208040" y="1644480"/>
            <a:ext cx="71640" cy="1224000"/>
          </a:xfrm>
          <a:custGeom>
            <a:avLst/>
            <a:gdLst>
              <a:gd name="textAreaLeft" fmla="*/ 20880 w 71640"/>
              <a:gd name="textAreaRight" fmla="*/ 72000 w 71640"/>
              <a:gd name="textAreaTop" fmla="*/ 0 h 1224000"/>
              <a:gd name="textAreaBottom" fmla="*/ 1224360 h 1224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Text Box 34"/>
          <p:cNvSpPr/>
          <p:nvPr/>
        </p:nvSpPr>
        <p:spPr>
          <a:xfrm>
            <a:off x="2638080" y="7556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Text Box 36"/>
          <p:cNvSpPr/>
          <p:nvPr/>
        </p:nvSpPr>
        <p:spPr>
          <a:xfrm>
            <a:off x="2924640" y="40892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36"/>
          <p:cNvSpPr/>
          <p:nvPr/>
        </p:nvSpPr>
        <p:spPr>
          <a:xfrm>
            <a:off x="3704040" y="53388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6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BDF959-07B6-4AA1-BE45-7945A7A7C950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Slide Number Placeholder 3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9C14AD-38DD-4E4E-AE75-3A39974054CA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Text Box 6"/>
          <p:cNvSpPr/>
          <p:nvPr/>
        </p:nvSpPr>
        <p:spPr>
          <a:xfrm>
            <a:off x="1341720" y="2554200"/>
            <a:ext cx="450360" cy="286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Text Box 7"/>
          <p:cNvSpPr/>
          <p:nvPr/>
        </p:nvSpPr>
        <p:spPr>
          <a:xfrm rot="16200000">
            <a:off x="152280" y="3800520"/>
            <a:ext cx="225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ercentage survival of cell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Text Box 8"/>
          <p:cNvSpPr/>
          <p:nvPr/>
        </p:nvSpPr>
        <p:spPr>
          <a:xfrm>
            <a:off x="2011320" y="5303880"/>
            <a:ext cx="348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20     30    40    50      60    70     80    90    10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Text Box 9"/>
          <p:cNvSpPr/>
          <p:nvPr/>
        </p:nvSpPr>
        <p:spPr>
          <a:xfrm>
            <a:off x="2614680" y="5649840"/>
            <a:ext cx="1715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oncentration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µ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Text Box 10"/>
          <p:cNvSpPr/>
          <p:nvPr/>
        </p:nvSpPr>
        <p:spPr>
          <a:xfrm>
            <a:off x="314640" y="26827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19" name="Object 10"/>
          <p:cNvGraphicFramePr/>
          <p:nvPr/>
        </p:nvGraphicFramePr>
        <p:xfrm>
          <a:off x="1595520" y="2484360"/>
          <a:ext cx="4281480" cy="3019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20" name="Object 1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95520" y="2484360"/>
                    <a:ext cx="4281480" cy="301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3T06:06:15Z</dcterms:created>
  <dc:creator>EGE I Lab</dc:creator>
  <dc:description/>
  <dc:language>en-US</dc:language>
  <cp:lastModifiedBy>Riya</cp:lastModifiedBy>
  <dcterms:modified xsi:type="dcterms:W3CDTF">2011-11-01T12:34:03Z</dcterms:modified>
  <cp:revision>104</cp:revision>
  <dc:subject/>
  <dc:title>PowerPoint Presentation</dc:title>
</cp:coreProperties>
</file>